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8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9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17" r:id="rId2"/>
    <p:sldId id="318" r:id="rId3"/>
    <p:sldId id="319" r:id="rId4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5" autoAdjust="0"/>
    <p:restoredTop sz="94435" autoAdjust="0"/>
  </p:normalViewPr>
  <p:slideViewPr>
    <p:cSldViewPr snapToGrid="0" snapToObjects="1">
      <p:cViewPr>
        <p:scale>
          <a:sx n="114" d="100"/>
          <a:sy n="114" d="100"/>
        </p:scale>
        <p:origin x="1406" y="-27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u\Desktop\paper\growth%20curve.9.11.18\GROWTH%20CURVE%20final%2014.12.19%20(version%20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about:blank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u\Desktop\paper\growth%20curve.9.11.18\GROWTH%20CURVE%20final%2014.12.19%20(version%201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about:blank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about:blank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shu\Desktop\paper\growth%20curve.9.11.18\GROWTH%20CURVE%20final%2014.12.19%20(version%20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Unexposed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482838618485742"/>
          <c:y val="0.17280854652797301"/>
          <c:w val="0.74082605647179767"/>
          <c:h val="0.48601436700823047"/>
        </c:manualLayout>
      </c:layout>
      <c:lineChart>
        <c:grouping val="standard"/>
        <c:varyColors val="0"/>
        <c:ser>
          <c:idx val="0"/>
          <c:order val="0"/>
          <c:tx>
            <c:strRef>
              <c:f>Sheet4!$D$26</c:f>
              <c:strCache>
                <c:ptCount val="1"/>
                <c:pt idx="0">
                  <c:v>W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D$34:$D$38</c:f>
                <c:numCache>
                  <c:formatCode>General</c:formatCode>
                  <c:ptCount val="5"/>
                  <c:pt idx="0">
                    <c:v>1.0883244001675227E-3</c:v>
                  </c:pt>
                  <c:pt idx="1">
                    <c:v>5.2489300497021675E-3</c:v>
                  </c:pt>
                  <c:pt idx="2">
                    <c:v>2.2842540722666255E-2</c:v>
                  </c:pt>
                  <c:pt idx="3">
                    <c:v>2.4396345354717925E-2</c:v>
                  </c:pt>
                  <c:pt idx="4">
                    <c:v>7.4941087973598389E-3</c:v>
                  </c:pt>
                </c:numCache>
              </c:numRef>
            </c:plus>
            <c:minus>
              <c:numRef>
                <c:f>Sheet4!$D$34:$D$38</c:f>
                <c:numCache>
                  <c:formatCode>General</c:formatCode>
                  <c:ptCount val="5"/>
                  <c:pt idx="0">
                    <c:v>1.0883244001675227E-3</c:v>
                  </c:pt>
                  <c:pt idx="1">
                    <c:v>5.2489300497021675E-3</c:v>
                  </c:pt>
                  <c:pt idx="2">
                    <c:v>2.2842540722666255E-2</c:v>
                  </c:pt>
                  <c:pt idx="3">
                    <c:v>2.4396345354717925E-2</c:v>
                  </c:pt>
                  <c:pt idx="4">
                    <c:v>7.494108797359838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C$27:$C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D$27:$D$31</c:f>
              <c:numCache>
                <c:formatCode>General</c:formatCode>
                <c:ptCount val="5"/>
                <c:pt idx="0">
                  <c:v>1.5120000000000001E-2</c:v>
                </c:pt>
                <c:pt idx="1">
                  <c:v>5.4596666666666661E-2</c:v>
                </c:pt>
                <c:pt idx="2">
                  <c:v>0.36166666666666664</c:v>
                </c:pt>
                <c:pt idx="3">
                  <c:v>0.69713333333333338</c:v>
                </c:pt>
                <c:pt idx="4">
                  <c:v>0.829066666666666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A22-4726-AAA6-938D47F4E512}"/>
            </c:ext>
          </c:extLst>
        </c:ser>
        <c:ser>
          <c:idx val="1"/>
          <c:order val="1"/>
          <c:tx>
            <c:strRef>
              <c:f>Sheet4!$E$26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34:$E$38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plus>
            <c:minus>
              <c:numRef>
                <c:f>Sheet4!$E$34:$E$38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C$27:$C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E$27:$E$31</c:f>
              <c:numCache>
                <c:formatCode>General</c:formatCode>
                <c:ptCount val="5"/>
                <c:pt idx="0">
                  <c:v>1.24E-2</c:v>
                </c:pt>
                <c:pt idx="1">
                  <c:v>2.8539999999999999E-2</c:v>
                </c:pt>
                <c:pt idx="2">
                  <c:v>0.12238666666666669</c:v>
                </c:pt>
                <c:pt idx="3">
                  <c:v>0.38646666666666668</c:v>
                </c:pt>
                <c:pt idx="4">
                  <c:v>0.5266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A22-4726-AAA6-938D47F4E512}"/>
            </c:ext>
          </c:extLst>
        </c:ser>
        <c:ser>
          <c:idx val="2"/>
          <c:order val="2"/>
          <c:tx>
            <c:strRef>
              <c:f>Sheet4!$F$26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F$34:$F$38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plus>
            <c:minus>
              <c:numRef>
                <c:f>Sheet4!$F$34:$F$38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C$27:$C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F$27:$F$31</c:f>
              <c:numCache>
                <c:formatCode>General</c:formatCode>
                <c:ptCount val="5"/>
                <c:pt idx="0">
                  <c:v>1.6390000000000002E-2</c:v>
                </c:pt>
                <c:pt idx="1">
                  <c:v>7.0330000000000004E-2</c:v>
                </c:pt>
                <c:pt idx="2">
                  <c:v>0.39206666666666662</c:v>
                </c:pt>
                <c:pt idx="3">
                  <c:v>0.66570000000000007</c:v>
                </c:pt>
                <c:pt idx="4">
                  <c:v>0.8513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A22-4726-AAA6-938D47F4E512}"/>
            </c:ext>
          </c:extLst>
        </c:ser>
        <c:ser>
          <c:idx val="3"/>
          <c:order val="3"/>
          <c:tx>
            <c:strRef>
              <c:f>Sheet4!$G$26</c:f>
              <c:strCache>
                <c:ptCount val="1"/>
                <c:pt idx="0">
                  <c:v>hPrxII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G$34:$G$38</c:f>
                <c:numCache>
                  <c:formatCode>General</c:formatCode>
                  <c:ptCount val="5"/>
                  <c:pt idx="0">
                    <c:v>2.9084904446579586E-3</c:v>
                  </c:pt>
                  <c:pt idx="1">
                    <c:v>5.0941551474868235E-3</c:v>
                  </c:pt>
                  <c:pt idx="2">
                    <c:v>1.5909954954891187E-2</c:v>
                  </c:pt>
                  <c:pt idx="3">
                    <c:v>1.5349104208389471E-2</c:v>
                  </c:pt>
                  <c:pt idx="4">
                    <c:v>2.2851586378192623E-2</c:v>
                  </c:pt>
                </c:numCache>
              </c:numRef>
            </c:plus>
            <c:minus>
              <c:numRef>
                <c:f>Sheet4!$G$34:$G$38</c:f>
                <c:numCache>
                  <c:formatCode>General</c:formatCode>
                  <c:ptCount val="5"/>
                  <c:pt idx="0">
                    <c:v>2.9084904446579586E-3</c:v>
                  </c:pt>
                  <c:pt idx="1">
                    <c:v>5.0941551474868235E-3</c:v>
                  </c:pt>
                  <c:pt idx="2">
                    <c:v>1.5909954954891187E-2</c:v>
                  </c:pt>
                  <c:pt idx="3">
                    <c:v>1.5349104208389471E-2</c:v>
                  </c:pt>
                  <c:pt idx="4">
                    <c:v>2.28515863781926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4!$C$27:$C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G$27:$G$31</c:f>
              <c:numCache>
                <c:formatCode>General</c:formatCode>
                <c:ptCount val="5"/>
                <c:pt idx="0">
                  <c:v>1.6396666666666667E-2</c:v>
                </c:pt>
                <c:pt idx="1">
                  <c:v>5.0786666666666667E-2</c:v>
                </c:pt>
                <c:pt idx="2">
                  <c:v>0.35233333333333333</c:v>
                </c:pt>
                <c:pt idx="3">
                  <c:v>0.61770000000000003</c:v>
                </c:pt>
                <c:pt idx="4">
                  <c:v>0.8175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A22-4726-AAA6-938D47F4E5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20689016"/>
        <c:axId val="520688624"/>
      </c:lineChart>
      <c:catAx>
        <c:axId val="5206890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0688624"/>
        <c:crosses val="autoZero"/>
        <c:auto val="1"/>
        <c:lblAlgn val="ctr"/>
        <c:lblOffset val="100"/>
        <c:noMultiLvlLbl val="0"/>
      </c:catAx>
      <c:valAx>
        <c:axId val="520688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</a:t>
                </a:r>
                <a:r>
                  <a:rPr lang="en-US" baseline="0"/>
                  <a:t> </a:t>
                </a:r>
                <a:r>
                  <a:rPr lang="en-US"/>
                  <a:t>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06890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/>
              <a:t>H</a:t>
            </a:r>
            <a:r>
              <a:rPr lang="en-US" sz="900" dirty="0"/>
              <a:t>2</a:t>
            </a:r>
            <a:r>
              <a:rPr lang="en-US" sz="1400" dirty="0"/>
              <a:t>O</a:t>
            </a:r>
            <a:r>
              <a:rPr lang="en-US" sz="900" dirty="0"/>
              <a:t>2</a:t>
            </a:r>
            <a:r>
              <a:rPr lang="en-US" sz="1400" dirty="0"/>
              <a:t> (1 mM)</a:t>
            </a:r>
          </a:p>
        </c:rich>
      </c:tx>
      <c:layout>
        <c:manualLayout>
          <c:xMode val="edge"/>
          <c:yMode val="edge"/>
          <c:x val="0.45577821095517751"/>
          <c:y val="8.3428725651692404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P$26</c:f>
              <c:strCache>
                <c:ptCount val="1"/>
                <c:pt idx="0">
                  <c:v>W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P$34:$P$38</c:f>
                <c:numCache>
                  <c:formatCode>General</c:formatCode>
                  <c:ptCount val="5"/>
                  <c:pt idx="0">
                    <c:v>9.0615488006558068E-4</c:v>
                  </c:pt>
                  <c:pt idx="1">
                    <c:v>2.0099378099831854E-3</c:v>
                  </c:pt>
                  <c:pt idx="2">
                    <c:v>7.5664831108426239E-3</c:v>
                  </c:pt>
                  <c:pt idx="3">
                    <c:v>4.5674573524737763E-3</c:v>
                  </c:pt>
                  <c:pt idx="4">
                    <c:v>1.8898721297131906E-2</c:v>
                  </c:pt>
                </c:numCache>
              </c:numRef>
            </c:plus>
            <c:minus>
              <c:numRef>
                <c:f>Sheet4!$P$34:$P$38</c:f>
                <c:numCache>
                  <c:formatCode>General</c:formatCode>
                  <c:ptCount val="5"/>
                  <c:pt idx="0">
                    <c:v>9.0615488006558068E-4</c:v>
                  </c:pt>
                  <c:pt idx="1">
                    <c:v>2.0099378099831854E-3</c:v>
                  </c:pt>
                  <c:pt idx="2">
                    <c:v>7.5664831108426239E-3</c:v>
                  </c:pt>
                  <c:pt idx="3">
                    <c:v>4.5674573524737763E-3</c:v>
                  </c:pt>
                  <c:pt idx="4">
                    <c:v>1.8898721297131906E-2</c:v>
                  </c:pt>
                </c:numCache>
              </c:numRef>
            </c:minus>
          </c:errBars>
          <c:cat>
            <c:numRef>
              <c:f>Sheet4!$O$27:$O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P$27:$P$31</c:f>
              <c:numCache>
                <c:formatCode>General</c:formatCode>
                <c:ptCount val="5"/>
                <c:pt idx="0">
                  <c:v>1.2423333333333333E-2</c:v>
                </c:pt>
                <c:pt idx="1">
                  <c:v>3.6170000000000001E-2</c:v>
                </c:pt>
                <c:pt idx="2">
                  <c:v>0.20593333333333333</c:v>
                </c:pt>
                <c:pt idx="3">
                  <c:v>0.67136666666666667</c:v>
                </c:pt>
                <c:pt idx="4">
                  <c:v>0.8555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EE1-448F-BE90-994DEB644954}"/>
            </c:ext>
          </c:extLst>
        </c:ser>
        <c:ser>
          <c:idx val="1"/>
          <c:order val="1"/>
          <c:tx>
            <c:strRef>
              <c:f>Sheet4!$Q$26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Q$34:$Q$38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plus>
            <c:minus>
              <c:numRef>
                <c:f>Sheet4!$Q$34:$Q$38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minus>
          </c:errBars>
          <c:cat>
            <c:numRef>
              <c:f>Sheet4!$O$27:$O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Q$27:$Q$31</c:f>
              <c:numCache>
                <c:formatCode>General</c:formatCode>
                <c:ptCount val="5"/>
                <c:pt idx="0">
                  <c:v>1.1679E-2</c:v>
                </c:pt>
                <c:pt idx="1">
                  <c:v>1.6923333333333335E-2</c:v>
                </c:pt>
                <c:pt idx="2">
                  <c:v>3.3476666666666662E-2</c:v>
                </c:pt>
                <c:pt idx="3">
                  <c:v>7.2386666666666669E-2</c:v>
                </c:pt>
                <c:pt idx="4">
                  <c:v>0.138033333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EE1-448F-BE90-994DEB644954}"/>
            </c:ext>
          </c:extLst>
        </c:ser>
        <c:ser>
          <c:idx val="2"/>
          <c:order val="2"/>
          <c:tx>
            <c:strRef>
              <c:f>Sheet4!$R$26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R$34:$R$38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plus>
            <c:minus>
              <c:numRef>
                <c:f>Sheet4!$R$34:$R$38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minus>
          </c:errBars>
          <c:cat>
            <c:numRef>
              <c:f>Sheet4!$O$27:$O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R$27:$R$31</c:f>
              <c:numCache>
                <c:formatCode>General</c:formatCode>
                <c:ptCount val="5"/>
                <c:pt idx="0">
                  <c:v>1.4486666666666667E-2</c:v>
                </c:pt>
                <c:pt idx="1">
                  <c:v>2.3470000000000001E-2</c:v>
                </c:pt>
                <c:pt idx="2">
                  <c:v>0.16793333333333335</c:v>
                </c:pt>
                <c:pt idx="3">
                  <c:v>0.4995</c:v>
                </c:pt>
                <c:pt idx="4">
                  <c:v>0.6962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EE1-448F-BE90-994DEB644954}"/>
            </c:ext>
          </c:extLst>
        </c:ser>
        <c:ser>
          <c:idx val="3"/>
          <c:order val="3"/>
          <c:tx>
            <c:strRef>
              <c:f>Sheet4!$S$26</c:f>
              <c:strCache>
                <c:ptCount val="1"/>
                <c:pt idx="0">
                  <c:v>hPrxII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S$34:$S$38</c:f>
                <c:numCache>
                  <c:formatCode>General</c:formatCode>
                  <c:ptCount val="5"/>
                  <c:pt idx="0">
                    <c:v>2.5662521310268788E-3</c:v>
                  </c:pt>
                  <c:pt idx="1">
                    <c:v>2.0633144856435884E-3</c:v>
                  </c:pt>
                  <c:pt idx="2">
                    <c:v>4.9289772434721844E-3</c:v>
                  </c:pt>
                  <c:pt idx="3">
                    <c:v>9.7837450225701783E-3</c:v>
                  </c:pt>
                  <c:pt idx="4">
                    <c:v>4.033201788488508E-2</c:v>
                  </c:pt>
                </c:numCache>
              </c:numRef>
            </c:plus>
            <c:minus>
              <c:numRef>
                <c:f>Sheet4!$S$34:$S$38</c:f>
                <c:numCache>
                  <c:formatCode>General</c:formatCode>
                  <c:ptCount val="5"/>
                  <c:pt idx="0">
                    <c:v>2.5662521310268788E-3</c:v>
                  </c:pt>
                  <c:pt idx="1">
                    <c:v>2.0633144856435884E-3</c:v>
                  </c:pt>
                  <c:pt idx="2">
                    <c:v>4.9289772434721844E-3</c:v>
                  </c:pt>
                  <c:pt idx="3">
                    <c:v>9.7837450225701783E-3</c:v>
                  </c:pt>
                  <c:pt idx="4">
                    <c:v>4.033201788488508E-2</c:v>
                  </c:pt>
                </c:numCache>
              </c:numRef>
            </c:minus>
          </c:errBars>
          <c:cat>
            <c:numRef>
              <c:f>Sheet4!$O$27:$O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S$27:$S$31</c:f>
              <c:numCache>
                <c:formatCode>General</c:formatCode>
                <c:ptCount val="5"/>
                <c:pt idx="0">
                  <c:v>1.7049999999999999E-2</c:v>
                </c:pt>
                <c:pt idx="1">
                  <c:v>1.5586666666666665E-2</c:v>
                </c:pt>
                <c:pt idx="2">
                  <c:v>9.608333333333334E-2</c:v>
                </c:pt>
                <c:pt idx="3">
                  <c:v>0.16603333333333334</c:v>
                </c:pt>
                <c:pt idx="4">
                  <c:v>0.37646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EE1-448F-BE90-994DEB6449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20687840"/>
        <c:axId val="520687448"/>
      </c:lineChart>
      <c:catAx>
        <c:axId val="5206878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0687448"/>
        <c:crosses val="autoZero"/>
        <c:auto val="1"/>
        <c:lblAlgn val="ctr"/>
        <c:lblOffset val="100"/>
        <c:noMultiLvlLbl val="0"/>
      </c:catAx>
      <c:valAx>
        <c:axId val="5206874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 at 600 n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0687840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NP (5 mM)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AB$26</c:f>
              <c:strCache>
                <c:ptCount val="1"/>
                <c:pt idx="0">
                  <c:v>W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B$34:$AB$38</c:f>
                <c:numCache>
                  <c:formatCode>General</c:formatCode>
                  <c:ptCount val="5"/>
                  <c:pt idx="0">
                    <c:v>3.3075670817082382E-4</c:v>
                  </c:pt>
                  <c:pt idx="1">
                    <c:v>7.7733615636994841E-3</c:v>
                  </c:pt>
                  <c:pt idx="2">
                    <c:v>1.5767107111536557E-2</c:v>
                  </c:pt>
                  <c:pt idx="3">
                    <c:v>1.5711832059523378E-2</c:v>
                  </c:pt>
                  <c:pt idx="4">
                    <c:v>2.1880394572920014E-2</c:v>
                  </c:pt>
                </c:numCache>
              </c:numRef>
            </c:plus>
            <c:minus>
              <c:numRef>
                <c:f>Sheet4!$AB$34:$AB$38</c:f>
                <c:numCache>
                  <c:formatCode>General</c:formatCode>
                  <c:ptCount val="5"/>
                  <c:pt idx="0">
                    <c:v>3.3075670817082382E-4</c:v>
                  </c:pt>
                  <c:pt idx="1">
                    <c:v>7.7733615636994841E-3</c:v>
                  </c:pt>
                  <c:pt idx="2">
                    <c:v>1.5767107111536557E-2</c:v>
                  </c:pt>
                  <c:pt idx="3">
                    <c:v>1.5711832059523378E-2</c:v>
                  </c:pt>
                  <c:pt idx="4">
                    <c:v>2.1880394572920014E-2</c:v>
                  </c:pt>
                </c:numCache>
              </c:numRef>
            </c:minus>
          </c:errBars>
          <c:cat>
            <c:numRef>
              <c:f>Sheet4!$AA$27:$AA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B$27:$AB$31</c:f>
              <c:numCache>
                <c:formatCode>General</c:formatCode>
                <c:ptCount val="5"/>
                <c:pt idx="0">
                  <c:v>1.7379999999999996E-2</c:v>
                </c:pt>
                <c:pt idx="1">
                  <c:v>6.8139999999999992E-2</c:v>
                </c:pt>
                <c:pt idx="2">
                  <c:v>0.45656666666666662</c:v>
                </c:pt>
                <c:pt idx="3">
                  <c:v>0.78833333333333322</c:v>
                </c:pt>
                <c:pt idx="4">
                  <c:v>0.8558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D8C-4569-BF3D-EA48A12E75C5}"/>
            </c:ext>
          </c:extLst>
        </c:ser>
        <c:ser>
          <c:idx val="1"/>
          <c:order val="1"/>
          <c:tx>
            <c:strRef>
              <c:f>Sheet4!$AC$26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C$34:$AC$38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plus>
            <c:minus>
              <c:numRef>
                <c:f>Sheet4!$AC$34:$AC$38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minus>
          </c:errBars>
          <c:cat>
            <c:numRef>
              <c:f>Sheet4!$AA$27:$AA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C$27:$AC$31</c:f>
              <c:numCache>
                <c:formatCode>General</c:formatCode>
                <c:ptCount val="5"/>
                <c:pt idx="0">
                  <c:v>1.6086666666666666E-2</c:v>
                </c:pt>
                <c:pt idx="1">
                  <c:v>3.9949999999999999E-2</c:v>
                </c:pt>
                <c:pt idx="2">
                  <c:v>0.18233333333333332</c:v>
                </c:pt>
                <c:pt idx="3">
                  <c:v>0.36370666666666668</c:v>
                </c:pt>
                <c:pt idx="4">
                  <c:v>0.3819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D8C-4569-BF3D-EA48A12E75C5}"/>
            </c:ext>
          </c:extLst>
        </c:ser>
        <c:ser>
          <c:idx val="2"/>
          <c:order val="2"/>
          <c:tx>
            <c:strRef>
              <c:f>Sheet4!$AD$26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D$34:$AD$38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plus>
            <c:minus>
              <c:numRef>
                <c:f>Sheet4!$AD$34:$AD$38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minus>
          </c:errBars>
          <c:cat>
            <c:numRef>
              <c:f>Sheet4!$AA$27:$AA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D$27:$AD$31</c:f>
              <c:numCache>
                <c:formatCode>General</c:formatCode>
                <c:ptCount val="5"/>
                <c:pt idx="0">
                  <c:v>1.7393333333333334E-2</c:v>
                </c:pt>
                <c:pt idx="1">
                  <c:v>6.9830000000000003E-2</c:v>
                </c:pt>
                <c:pt idx="2">
                  <c:v>0.41741</c:v>
                </c:pt>
                <c:pt idx="3">
                  <c:v>0.7954</c:v>
                </c:pt>
                <c:pt idx="4">
                  <c:v>0.8158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D8C-4569-BF3D-EA48A12E75C5}"/>
            </c:ext>
          </c:extLst>
        </c:ser>
        <c:ser>
          <c:idx val="3"/>
          <c:order val="3"/>
          <c:tx>
            <c:strRef>
              <c:f>Sheet4!$AE$26</c:f>
              <c:strCache>
                <c:ptCount val="1"/>
                <c:pt idx="0">
                  <c:v>hPrxII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E$34:$AE$38</c:f>
                <c:numCache>
                  <c:formatCode>General</c:formatCode>
                  <c:ptCount val="5"/>
                  <c:pt idx="0">
                    <c:v>5.3235326616824636E-4</c:v>
                  </c:pt>
                  <c:pt idx="1">
                    <c:v>4.6790508296733289E-3</c:v>
                  </c:pt>
                  <c:pt idx="2">
                    <c:v>8.2378192907265561E-3</c:v>
                  </c:pt>
                  <c:pt idx="3">
                    <c:v>1.0160052493302707E-2</c:v>
                  </c:pt>
                  <c:pt idx="4">
                    <c:v>6.6679582082273571E-3</c:v>
                  </c:pt>
                </c:numCache>
              </c:numRef>
            </c:plus>
            <c:minus>
              <c:numRef>
                <c:f>Sheet4!$AE$34:$AE$38</c:f>
                <c:numCache>
                  <c:formatCode>General</c:formatCode>
                  <c:ptCount val="5"/>
                  <c:pt idx="0">
                    <c:v>5.3235326616824636E-4</c:v>
                  </c:pt>
                  <c:pt idx="1">
                    <c:v>4.6790508296733289E-3</c:v>
                  </c:pt>
                  <c:pt idx="2">
                    <c:v>8.2378192907265561E-3</c:v>
                  </c:pt>
                  <c:pt idx="3">
                    <c:v>1.0160052493302707E-2</c:v>
                  </c:pt>
                  <c:pt idx="4">
                    <c:v>6.6679582082273571E-3</c:v>
                  </c:pt>
                </c:numCache>
              </c:numRef>
            </c:minus>
          </c:errBars>
          <c:cat>
            <c:numRef>
              <c:f>Sheet4!$AA$27:$AA$31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E$27:$AE$31</c:f>
              <c:numCache>
                <c:formatCode>General</c:formatCode>
                <c:ptCount val="5"/>
                <c:pt idx="0">
                  <c:v>1.6299999999999999E-2</c:v>
                </c:pt>
                <c:pt idx="1">
                  <c:v>4.5763333333333329E-2</c:v>
                </c:pt>
                <c:pt idx="2">
                  <c:v>0.28023333333333333</c:v>
                </c:pt>
                <c:pt idx="3">
                  <c:v>0.46606666666666668</c:v>
                </c:pt>
                <c:pt idx="4">
                  <c:v>0.5266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D8C-4569-BF3D-EA48A12E75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9843744"/>
        <c:axId val="619847664"/>
      </c:lineChart>
      <c:catAx>
        <c:axId val="619843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7664"/>
        <c:crosses val="autoZero"/>
        <c:auto val="1"/>
        <c:lblAlgn val="ctr"/>
        <c:lblOffset val="100"/>
        <c:noMultiLvlLbl val="0"/>
      </c:catAx>
      <c:valAx>
        <c:axId val="6198476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 at 600 n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3744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Unexposed</a:t>
            </a:r>
            <a:endParaRPr lang="en-US" sz="140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endParaRPr lang="en-US" sz="1400"/>
          </a:p>
        </c:rich>
      </c:tx>
      <c:layout>
        <c:manualLayout>
          <c:xMode val="edge"/>
          <c:yMode val="edge"/>
          <c:x val="0.39301451498945705"/>
          <c:y val="0.1343284108310458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D$42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D$50:$D$54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plus>
            <c:minus>
              <c:numRef>
                <c:f>Sheet4!$D$50:$D$54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minus>
          </c:errBars>
          <c:cat>
            <c:numRef>
              <c:f>Sheet4!$C$43:$C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D$43:$D$47</c:f>
              <c:numCache>
                <c:formatCode>General</c:formatCode>
                <c:ptCount val="5"/>
                <c:pt idx="0">
                  <c:v>1.24E-2</c:v>
                </c:pt>
                <c:pt idx="1">
                  <c:v>2.8539999999999999E-2</c:v>
                </c:pt>
                <c:pt idx="2">
                  <c:v>0.12238666666666669</c:v>
                </c:pt>
                <c:pt idx="3">
                  <c:v>0.38646666666666668</c:v>
                </c:pt>
                <c:pt idx="4">
                  <c:v>0.5266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E72-4DBD-BFF1-39AF34A57365}"/>
            </c:ext>
          </c:extLst>
        </c:ser>
        <c:ser>
          <c:idx val="1"/>
          <c:order val="1"/>
          <c:tx>
            <c:strRef>
              <c:f>Sheet4!$E$42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50:$E$54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plus>
            <c:minus>
              <c:numRef>
                <c:f>Sheet4!$E$50:$E$54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minus>
          </c:errBars>
          <c:cat>
            <c:numRef>
              <c:f>Sheet4!$C$43:$C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E$43:$E$47</c:f>
              <c:numCache>
                <c:formatCode>General</c:formatCode>
                <c:ptCount val="5"/>
                <c:pt idx="0">
                  <c:v>1.6390000000000002E-2</c:v>
                </c:pt>
                <c:pt idx="1">
                  <c:v>7.0330000000000004E-2</c:v>
                </c:pt>
                <c:pt idx="2">
                  <c:v>0.39206666666666662</c:v>
                </c:pt>
                <c:pt idx="3">
                  <c:v>0.66570000000000007</c:v>
                </c:pt>
                <c:pt idx="4">
                  <c:v>0.8513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E72-4DBD-BFF1-39AF34A57365}"/>
            </c:ext>
          </c:extLst>
        </c:ser>
        <c:ser>
          <c:idx val="2"/>
          <c:order val="2"/>
          <c:tx>
            <c:strRef>
              <c:f>Sheet4!$F$42</c:f>
              <c:strCache>
                <c:ptCount val="1"/>
                <c:pt idx="0">
                  <c:v>Tsa1C48S,C170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F$50:$F$54</c:f>
                <c:numCache>
                  <c:formatCode>General</c:formatCode>
                  <c:ptCount val="5"/>
                  <c:pt idx="0">
                    <c:v>9.9300889556270654E-4</c:v>
                  </c:pt>
                  <c:pt idx="1">
                    <c:v>1.3277863784007823E-3</c:v>
                  </c:pt>
                  <c:pt idx="2">
                    <c:v>9.3397894337434936E-3</c:v>
                  </c:pt>
                  <c:pt idx="3">
                    <c:v>2.5171842734823119E-2</c:v>
                  </c:pt>
                  <c:pt idx="4">
                    <c:v>2.4826028008255122E-2</c:v>
                  </c:pt>
                </c:numCache>
              </c:numRef>
            </c:plus>
            <c:minus>
              <c:numRef>
                <c:f>Sheet4!$F$50:$F$54</c:f>
                <c:numCache>
                  <c:formatCode>General</c:formatCode>
                  <c:ptCount val="5"/>
                  <c:pt idx="0">
                    <c:v>9.9300889556270654E-4</c:v>
                  </c:pt>
                  <c:pt idx="1">
                    <c:v>1.3277863784007823E-3</c:v>
                  </c:pt>
                  <c:pt idx="2">
                    <c:v>9.3397894337434936E-3</c:v>
                  </c:pt>
                  <c:pt idx="3">
                    <c:v>2.5171842734823119E-2</c:v>
                  </c:pt>
                  <c:pt idx="4">
                    <c:v>2.4826028008255122E-2</c:v>
                  </c:pt>
                </c:numCache>
              </c:numRef>
            </c:minus>
          </c:errBars>
          <c:cat>
            <c:numRef>
              <c:f>Sheet4!$C$43:$C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F$43:$F$47</c:f>
              <c:numCache>
                <c:formatCode>General</c:formatCode>
                <c:ptCount val="5"/>
                <c:pt idx="0">
                  <c:v>1.4126666666666668E-2</c:v>
                </c:pt>
                <c:pt idx="1">
                  <c:v>2.7053333333333332E-2</c:v>
                </c:pt>
                <c:pt idx="2">
                  <c:v>0.12746666666666664</c:v>
                </c:pt>
                <c:pt idx="3">
                  <c:v>0.38786666666666664</c:v>
                </c:pt>
                <c:pt idx="4">
                  <c:v>0.5531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E72-4DBD-BFF1-39AF34A57365}"/>
            </c:ext>
          </c:extLst>
        </c:ser>
        <c:ser>
          <c:idx val="3"/>
          <c:order val="3"/>
          <c:tx>
            <c:strRef>
              <c:f>Sheet4!$G$42</c:f>
              <c:strCache>
                <c:ptCount val="1"/>
                <c:pt idx="0">
                  <c:v>C52S,C173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G$50:$G$54</c:f>
                <c:numCache>
                  <c:formatCode>General</c:formatCode>
                  <c:ptCount val="5"/>
                  <c:pt idx="0">
                    <c:v>7.0658804594096161E-4</c:v>
                  </c:pt>
                  <c:pt idx="1">
                    <c:v>1.73597715038726E-3</c:v>
                  </c:pt>
                  <c:pt idx="2">
                    <c:v>9.0139706382185662E-3</c:v>
                  </c:pt>
                  <c:pt idx="3">
                    <c:v>1.4686104543638081E-2</c:v>
                  </c:pt>
                  <c:pt idx="4">
                    <c:v>1.4523486725530679E-2</c:v>
                  </c:pt>
                </c:numCache>
              </c:numRef>
            </c:plus>
            <c:minus>
              <c:numRef>
                <c:f>Sheet4!$G$50:$G$54</c:f>
                <c:numCache>
                  <c:formatCode>General</c:formatCode>
                  <c:ptCount val="5"/>
                  <c:pt idx="0">
                    <c:v>7.0658804594096161E-4</c:v>
                  </c:pt>
                  <c:pt idx="1">
                    <c:v>1.73597715038726E-3</c:v>
                  </c:pt>
                  <c:pt idx="2">
                    <c:v>9.0139706382185662E-3</c:v>
                  </c:pt>
                  <c:pt idx="3">
                    <c:v>1.4686104543638081E-2</c:v>
                  </c:pt>
                  <c:pt idx="4">
                    <c:v>1.4523486725530679E-2</c:v>
                  </c:pt>
                </c:numCache>
              </c:numRef>
            </c:minus>
          </c:errBars>
          <c:cat>
            <c:numRef>
              <c:f>Sheet4!$C$43:$C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G$43:$G$47</c:f>
              <c:numCache>
                <c:formatCode>General</c:formatCode>
                <c:ptCount val="5"/>
                <c:pt idx="0">
                  <c:v>1.6046666666666667E-2</c:v>
                </c:pt>
                <c:pt idx="1">
                  <c:v>7.1866666666666676E-2</c:v>
                </c:pt>
                <c:pt idx="2">
                  <c:v>0.33863333333333334</c:v>
                </c:pt>
                <c:pt idx="3">
                  <c:v>0.6549666666666667</c:v>
                </c:pt>
                <c:pt idx="4">
                  <c:v>0.8259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E72-4DBD-BFF1-39AF34A573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9843352"/>
        <c:axId val="619845704"/>
      </c:lineChart>
      <c:catAx>
        <c:axId val="6198433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5704"/>
        <c:crosses val="autoZero"/>
        <c:auto val="1"/>
        <c:lblAlgn val="ctr"/>
        <c:lblOffset val="100"/>
        <c:noMultiLvlLbl val="0"/>
      </c:catAx>
      <c:valAx>
        <c:axId val="6198457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</a:t>
                </a:r>
                <a:r>
                  <a:rPr lang="en-US" baseline="0"/>
                  <a:t> </a:t>
                </a:r>
                <a:r>
                  <a:rPr lang="en-US"/>
                  <a:t>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3352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H</a:t>
            </a:r>
            <a:r>
              <a:rPr lang="en-US" sz="900" b="0" i="0" baseline="0">
                <a:effectLst/>
              </a:rPr>
              <a:t>2</a:t>
            </a:r>
            <a:r>
              <a:rPr lang="en-US" sz="1400" b="0" i="0" baseline="0">
                <a:effectLst/>
              </a:rPr>
              <a:t>O</a:t>
            </a:r>
            <a:r>
              <a:rPr lang="en-US" sz="900" b="0" i="0" baseline="0">
                <a:effectLst/>
              </a:rPr>
              <a:t>2</a:t>
            </a:r>
            <a:r>
              <a:rPr lang="en-US" sz="1400" b="0" i="0" baseline="0">
                <a:effectLst/>
              </a:rPr>
              <a:t> (1 mM)</a:t>
            </a:r>
            <a:endParaRPr lang="en-US" sz="1400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endParaRPr lang="en-US" sz="1400"/>
          </a:p>
        </c:rich>
      </c:tx>
      <c:layout>
        <c:manualLayout>
          <c:xMode val="edge"/>
          <c:yMode val="edge"/>
          <c:x val="0.42043290145697826"/>
          <c:y val="0.1442545629406294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P$42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P$50:$P$54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plus>
            <c:minus>
              <c:numRef>
                <c:f>Sheet4!$P$50:$P$54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minus>
          </c:errBars>
          <c:cat>
            <c:numRef>
              <c:f>Sheet4!$O$43:$O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P$43:$P$47</c:f>
              <c:numCache>
                <c:formatCode>General</c:formatCode>
                <c:ptCount val="5"/>
                <c:pt idx="0">
                  <c:v>1.1679E-2</c:v>
                </c:pt>
                <c:pt idx="1">
                  <c:v>1.6923333333333335E-2</c:v>
                </c:pt>
                <c:pt idx="2">
                  <c:v>3.3476666666666662E-2</c:v>
                </c:pt>
                <c:pt idx="3">
                  <c:v>7.2386666666666669E-2</c:v>
                </c:pt>
                <c:pt idx="4">
                  <c:v>0.138033333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D0-4B32-91A2-137CD0F80A1C}"/>
            </c:ext>
          </c:extLst>
        </c:ser>
        <c:ser>
          <c:idx val="1"/>
          <c:order val="1"/>
          <c:tx>
            <c:strRef>
              <c:f>Sheet4!$Q$42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Q$50:$Q$54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plus>
            <c:minus>
              <c:numRef>
                <c:f>Sheet4!$Q$50:$Q$54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minus>
          </c:errBars>
          <c:cat>
            <c:numRef>
              <c:f>Sheet4!$O$43:$O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Q$43:$Q$47</c:f>
              <c:numCache>
                <c:formatCode>General</c:formatCode>
                <c:ptCount val="5"/>
                <c:pt idx="0">
                  <c:v>1.4486666666666667E-2</c:v>
                </c:pt>
                <c:pt idx="1">
                  <c:v>2.3470000000000001E-2</c:v>
                </c:pt>
                <c:pt idx="2">
                  <c:v>0.16793333333333335</c:v>
                </c:pt>
                <c:pt idx="3">
                  <c:v>0.4995</c:v>
                </c:pt>
                <c:pt idx="4">
                  <c:v>0.6962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5D0-4B32-91A2-137CD0F80A1C}"/>
            </c:ext>
          </c:extLst>
        </c:ser>
        <c:ser>
          <c:idx val="2"/>
          <c:order val="2"/>
          <c:tx>
            <c:strRef>
              <c:f>Sheet4!$R$42</c:f>
              <c:strCache>
                <c:ptCount val="1"/>
                <c:pt idx="0">
                  <c:v>Tsa1C48S,C170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R$50:$R$54</c:f>
                <c:numCache>
                  <c:formatCode>General</c:formatCode>
                  <c:ptCount val="5"/>
                  <c:pt idx="0">
                    <c:v>7.2522410329497447E-4</c:v>
                  </c:pt>
                  <c:pt idx="1">
                    <c:v>2.6059771040181198E-3</c:v>
                  </c:pt>
                  <c:pt idx="2">
                    <c:v>6.1034143449930267E-4</c:v>
                  </c:pt>
                  <c:pt idx="3">
                    <c:v>1.6607076804784151E-3</c:v>
                  </c:pt>
                  <c:pt idx="4">
                    <c:v>9.7151942852420625E-3</c:v>
                  </c:pt>
                </c:numCache>
              </c:numRef>
            </c:plus>
            <c:minus>
              <c:numRef>
                <c:f>Sheet4!$R$50:$R$54</c:f>
                <c:numCache>
                  <c:formatCode>General</c:formatCode>
                  <c:ptCount val="5"/>
                  <c:pt idx="0">
                    <c:v>7.2522410329497447E-4</c:v>
                  </c:pt>
                  <c:pt idx="1">
                    <c:v>2.6059771040181198E-3</c:v>
                  </c:pt>
                  <c:pt idx="2">
                    <c:v>6.1034143449930267E-4</c:v>
                  </c:pt>
                  <c:pt idx="3">
                    <c:v>1.6607076804784151E-3</c:v>
                  </c:pt>
                  <c:pt idx="4">
                    <c:v>9.7151942852420625E-3</c:v>
                  </c:pt>
                </c:numCache>
              </c:numRef>
            </c:minus>
          </c:errBars>
          <c:cat>
            <c:numRef>
              <c:f>Sheet4!$O$43:$O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R$43:$R$47</c:f>
              <c:numCache>
                <c:formatCode>General</c:formatCode>
                <c:ptCount val="5"/>
                <c:pt idx="0">
                  <c:v>1.316E-2</c:v>
                </c:pt>
                <c:pt idx="1">
                  <c:v>1.6643333333333333E-2</c:v>
                </c:pt>
                <c:pt idx="2">
                  <c:v>3.2156666666666667E-2</c:v>
                </c:pt>
                <c:pt idx="3">
                  <c:v>7.6060000000000003E-2</c:v>
                </c:pt>
                <c:pt idx="4">
                  <c:v>0.14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5D0-4B32-91A2-137CD0F80A1C}"/>
            </c:ext>
          </c:extLst>
        </c:ser>
        <c:ser>
          <c:idx val="3"/>
          <c:order val="3"/>
          <c:tx>
            <c:strRef>
              <c:f>Sheet4!$S$42</c:f>
              <c:strCache>
                <c:ptCount val="1"/>
                <c:pt idx="0">
                  <c:v>C52S,C173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S$50:$S$54</c:f>
                <c:numCache>
                  <c:formatCode>General</c:formatCode>
                  <c:ptCount val="5"/>
                  <c:pt idx="0">
                    <c:v>3.9244957213209778E-4</c:v>
                  </c:pt>
                  <c:pt idx="1">
                    <c:v>1.1651394766293E-3</c:v>
                  </c:pt>
                  <c:pt idx="2">
                    <c:v>1.2746370071514369E-2</c:v>
                  </c:pt>
                  <c:pt idx="3">
                    <c:v>1.0885847080804801E-2</c:v>
                  </c:pt>
                  <c:pt idx="4">
                    <c:v>1.4149617191523828E-2</c:v>
                  </c:pt>
                </c:numCache>
              </c:numRef>
            </c:plus>
            <c:minus>
              <c:numRef>
                <c:f>Sheet4!$S$50:$S$54</c:f>
                <c:numCache>
                  <c:formatCode>General</c:formatCode>
                  <c:ptCount val="5"/>
                  <c:pt idx="0">
                    <c:v>3.9244957213209778E-4</c:v>
                  </c:pt>
                  <c:pt idx="1">
                    <c:v>1.1651394766293E-3</c:v>
                  </c:pt>
                  <c:pt idx="2">
                    <c:v>1.2746370071514369E-2</c:v>
                  </c:pt>
                  <c:pt idx="3">
                    <c:v>1.0885847080804801E-2</c:v>
                  </c:pt>
                  <c:pt idx="4">
                    <c:v>1.4149617191523828E-2</c:v>
                  </c:pt>
                </c:numCache>
              </c:numRef>
            </c:minus>
          </c:errBars>
          <c:cat>
            <c:numRef>
              <c:f>Sheet4!$O$43:$O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S$43:$S$47</c:f>
              <c:numCache>
                <c:formatCode>General</c:formatCode>
                <c:ptCount val="5"/>
                <c:pt idx="0">
                  <c:v>1.5443333333333335E-2</c:v>
                </c:pt>
                <c:pt idx="1">
                  <c:v>1.9039999999999998E-2</c:v>
                </c:pt>
                <c:pt idx="2">
                  <c:v>0.13957</c:v>
                </c:pt>
                <c:pt idx="3">
                  <c:v>0.33003333333333335</c:v>
                </c:pt>
                <c:pt idx="4">
                  <c:v>0.657666666666666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5D0-4B32-91A2-137CD0F80A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19848448"/>
        <c:axId val="619845312"/>
      </c:lineChart>
      <c:catAx>
        <c:axId val="619848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5312"/>
        <c:crosses val="autoZero"/>
        <c:auto val="1"/>
        <c:lblAlgn val="ctr"/>
        <c:lblOffset val="100"/>
        <c:noMultiLvlLbl val="0"/>
      </c:catAx>
      <c:valAx>
        <c:axId val="619845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 at 600 n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848448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SNP (5 mM)</a:t>
            </a:r>
            <a:endParaRPr lang="en-US" sz="1400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AB$42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B$50:$AB$54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plus>
            <c:minus>
              <c:numRef>
                <c:f>Sheet4!$AB$50:$AB$54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minus>
          </c:errBars>
          <c:cat>
            <c:numRef>
              <c:f>Sheet4!$AA$43:$AA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B$43:$AB$47</c:f>
              <c:numCache>
                <c:formatCode>General</c:formatCode>
                <c:ptCount val="5"/>
                <c:pt idx="0">
                  <c:v>1.6086666666666666E-2</c:v>
                </c:pt>
                <c:pt idx="1">
                  <c:v>3.9949999999999999E-2</c:v>
                </c:pt>
                <c:pt idx="2">
                  <c:v>0.18233333333333332</c:v>
                </c:pt>
                <c:pt idx="3">
                  <c:v>0.36370666666666668</c:v>
                </c:pt>
                <c:pt idx="4">
                  <c:v>0.3819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F26-478B-9D31-4BB487C62B19}"/>
            </c:ext>
          </c:extLst>
        </c:ser>
        <c:ser>
          <c:idx val="1"/>
          <c:order val="1"/>
          <c:tx>
            <c:strRef>
              <c:f>Sheet4!$AC$42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C$50:$AC$54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plus>
            <c:minus>
              <c:numRef>
                <c:f>Sheet4!$AC$50:$AC$54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minus>
          </c:errBars>
          <c:cat>
            <c:numRef>
              <c:f>Sheet4!$AA$43:$AA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C$43:$AC$47</c:f>
              <c:numCache>
                <c:formatCode>General</c:formatCode>
                <c:ptCount val="5"/>
                <c:pt idx="0">
                  <c:v>1.7393333333333334E-2</c:v>
                </c:pt>
                <c:pt idx="1">
                  <c:v>6.9830000000000003E-2</c:v>
                </c:pt>
                <c:pt idx="2">
                  <c:v>0.41741</c:v>
                </c:pt>
                <c:pt idx="3">
                  <c:v>0.7954</c:v>
                </c:pt>
                <c:pt idx="4">
                  <c:v>0.8158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F26-478B-9D31-4BB487C62B19}"/>
            </c:ext>
          </c:extLst>
        </c:ser>
        <c:ser>
          <c:idx val="2"/>
          <c:order val="2"/>
          <c:tx>
            <c:strRef>
              <c:f>Sheet4!$AD$42</c:f>
              <c:strCache>
                <c:ptCount val="1"/>
                <c:pt idx="0">
                  <c:v>Tsa1C48S,C170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D$50:$AD$54</c:f>
                <c:numCache>
                  <c:formatCode>General</c:formatCode>
                  <c:ptCount val="5"/>
                  <c:pt idx="0">
                    <c:v>3.4570869239867246E-3</c:v>
                  </c:pt>
                  <c:pt idx="1">
                    <c:v>6.9208417118151178E-3</c:v>
                  </c:pt>
                  <c:pt idx="2">
                    <c:v>8.0750644992264135E-3</c:v>
                  </c:pt>
                  <c:pt idx="3">
                    <c:v>7.3034238546040905E-3</c:v>
                  </c:pt>
                  <c:pt idx="4">
                    <c:v>1.942639956348062E-2</c:v>
                  </c:pt>
                </c:numCache>
              </c:numRef>
            </c:plus>
            <c:minus>
              <c:numRef>
                <c:f>Sheet4!$AD$50:$AD$54</c:f>
                <c:numCache>
                  <c:formatCode>General</c:formatCode>
                  <c:ptCount val="5"/>
                  <c:pt idx="0">
                    <c:v>3.4570869239867246E-3</c:v>
                  </c:pt>
                  <c:pt idx="1">
                    <c:v>6.9208417118151178E-3</c:v>
                  </c:pt>
                  <c:pt idx="2">
                    <c:v>8.0750644992264135E-3</c:v>
                  </c:pt>
                  <c:pt idx="3">
                    <c:v>7.3034238546040905E-3</c:v>
                  </c:pt>
                  <c:pt idx="4">
                    <c:v>1.942639956348062E-2</c:v>
                  </c:pt>
                </c:numCache>
              </c:numRef>
            </c:minus>
          </c:errBars>
          <c:cat>
            <c:numRef>
              <c:f>Sheet4!$AA$43:$AA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D$43:$AD$47</c:f>
              <c:numCache>
                <c:formatCode>General</c:formatCode>
                <c:ptCount val="5"/>
                <c:pt idx="0">
                  <c:v>2.427E-2</c:v>
                </c:pt>
                <c:pt idx="1">
                  <c:v>4.1619999999999997E-2</c:v>
                </c:pt>
                <c:pt idx="2">
                  <c:v>0.19293333333333332</c:v>
                </c:pt>
                <c:pt idx="3">
                  <c:v>0.39880000000000004</c:v>
                </c:pt>
                <c:pt idx="4">
                  <c:v>0.4602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F26-478B-9D31-4BB487C62B19}"/>
            </c:ext>
          </c:extLst>
        </c:ser>
        <c:ser>
          <c:idx val="3"/>
          <c:order val="3"/>
          <c:tx>
            <c:strRef>
              <c:f>Sheet4!$AE$42</c:f>
              <c:strCache>
                <c:ptCount val="1"/>
                <c:pt idx="0">
                  <c:v>C52S,C173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E$50:$AE$54</c:f>
                <c:numCache>
                  <c:formatCode>General</c:formatCode>
                  <c:ptCount val="5"/>
                  <c:pt idx="0">
                    <c:v>2.2605456568418753E-3</c:v>
                  </c:pt>
                  <c:pt idx="1">
                    <c:v>2.4758971437979136E-3</c:v>
                  </c:pt>
                  <c:pt idx="2">
                    <c:v>1.0185283501208999E-2</c:v>
                  </c:pt>
                  <c:pt idx="3">
                    <c:v>9.8359883421376016E-3</c:v>
                  </c:pt>
                  <c:pt idx="4">
                    <c:v>1.5972632844963308E-2</c:v>
                  </c:pt>
                </c:numCache>
              </c:numRef>
            </c:plus>
            <c:minus>
              <c:numRef>
                <c:f>Sheet4!$AE$50:$AE$54</c:f>
                <c:numCache>
                  <c:formatCode>General</c:formatCode>
                  <c:ptCount val="5"/>
                  <c:pt idx="0">
                    <c:v>2.2605456568418753E-3</c:v>
                  </c:pt>
                  <c:pt idx="1">
                    <c:v>2.4758971437979136E-3</c:v>
                  </c:pt>
                  <c:pt idx="2">
                    <c:v>1.0185283501208999E-2</c:v>
                  </c:pt>
                  <c:pt idx="3">
                    <c:v>9.8359883421376016E-3</c:v>
                  </c:pt>
                  <c:pt idx="4">
                    <c:v>1.5972632844963308E-2</c:v>
                  </c:pt>
                </c:numCache>
              </c:numRef>
            </c:minus>
          </c:errBars>
          <c:cat>
            <c:numRef>
              <c:f>Sheet4!$AA$43:$AA$47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E$43:$AE$47</c:f>
              <c:numCache>
                <c:formatCode>General</c:formatCode>
                <c:ptCount val="5"/>
                <c:pt idx="0">
                  <c:v>1.7913333333333333E-2</c:v>
                </c:pt>
                <c:pt idx="1">
                  <c:v>4.3926666666666669E-2</c:v>
                </c:pt>
                <c:pt idx="2">
                  <c:v>0.31790000000000002</c:v>
                </c:pt>
                <c:pt idx="3">
                  <c:v>0.43226666666666663</c:v>
                </c:pt>
                <c:pt idx="4">
                  <c:v>0.5546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F26-478B-9D31-4BB487C62B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34138648"/>
        <c:axId val="334137864"/>
      </c:lineChart>
      <c:catAx>
        <c:axId val="3341386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4137864"/>
        <c:crosses val="autoZero"/>
        <c:auto val="1"/>
        <c:lblAlgn val="ctr"/>
        <c:lblOffset val="100"/>
        <c:noMultiLvlLbl val="0"/>
      </c:catAx>
      <c:valAx>
        <c:axId val="3341378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 at 600 n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4138648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u="none" strike="noStrike" baseline="0">
                <a:effectLst/>
              </a:rPr>
              <a:t>H</a:t>
            </a:r>
            <a:r>
              <a:rPr lang="en-US" sz="900" b="0" i="0" u="none" strike="noStrike" baseline="0">
                <a:effectLst/>
              </a:rPr>
              <a:t>2</a:t>
            </a:r>
            <a:r>
              <a:rPr lang="en-US" sz="1400" b="0" i="0" u="none" strike="noStrike" baseline="0">
                <a:effectLst/>
              </a:rPr>
              <a:t>O</a:t>
            </a:r>
            <a:r>
              <a:rPr lang="en-US" sz="900" b="0" i="0" u="none" strike="noStrike" baseline="0">
                <a:effectLst/>
              </a:rPr>
              <a:t>2</a:t>
            </a:r>
            <a:r>
              <a:rPr lang="en-US" sz="1400" b="0" i="0" u="none" strike="noStrike" baseline="0">
                <a:effectLst/>
              </a:rPr>
              <a:t> (1 mM)</a:t>
            </a:r>
            <a:endParaRPr lang="en-US" sz="1400"/>
          </a:p>
        </c:rich>
      </c:tx>
      <c:layout>
        <c:manualLayout>
          <c:xMode val="edge"/>
          <c:yMode val="edge"/>
          <c:x val="0.40980714942118379"/>
          <c:y val="0.12024398358655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2"/>
          <c:order val="0"/>
          <c:tx>
            <c:strRef>
              <c:f>Sheet4!$S$118</c:f>
              <c:strCache>
                <c:ptCount val="1"/>
                <c:pt idx="0">
                  <c:v>C83T</c:v>
                </c:pt>
              </c:strCache>
            </c:strRef>
          </c:tx>
          <c:spPr>
            <a:ln w="28575" cap="rnd" cmpd="sng" algn="ctr">
              <a:solidFill>
                <a:schemeClr val="accent3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S$126:$S$130</c:f>
                <c:numCache>
                  <c:formatCode>General</c:formatCode>
                  <c:ptCount val="5"/>
                  <c:pt idx="0">
                    <c:v>1.2481252608078505E-3</c:v>
                  </c:pt>
                  <c:pt idx="1">
                    <c:v>1.9937443834821618E-3</c:v>
                  </c:pt>
                  <c:pt idx="2">
                    <c:v>1.743509822169062E-2</c:v>
                  </c:pt>
                  <c:pt idx="3">
                    <c:v>9.0336408311746958E-3</c:v>
                  </c:pt>
                  <c:pt idx="4">
                    <c:v>1.201755660135065E-2</c:v>
                  </c:pt>
                </c:numCache>
              </c:numRef>
            </c:plus>
            <c:minus>
              <c:numRef>
                <c:f>Sheet4!$S$126:$S$130</c:f>
                <c:numCache>
                  <c:formatCode>General</c:formatCode>
                  <c:ptCount val="5"/>
                  <c:pt idx="0">
                    <c:v>1.2481252608078505E-3</c:v>
                  </c:pt>
                  <c:pt idx="1">
                    <c:v>1.9937443834821618E-3</c:v>
                  </c:pt>
                  <c:pt idx="2">
                    <c:v>1.743509822169062E-2</c:v>
                  </c:pt>
                  <c:pt idx="3">
                    <c:v>9.0336408311746958E-3</c:v>
                  </c:pt>
                  <c:pt idx="4">
                    <c:v>1.201755660135065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R$119:$R$123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S$119:$S$123</c:f>
              <c:numCache>
                <c:formatCode>General</c:formatCode>
                <c:ptCount val="5"/>
                <c:pt idx="0">
                  <c:v>1.4716666666666668E-2</c:v>
                </c:pt>
                <c:pt idx="1">
                  <c:v>2.1986666666666668E-2</c:v>
                </c:pt>
                <c:pt idx="2">
                  <c:v>0.16028000000000001</c:v>
                </c:pt>
                <c:pt idx="3">
                  <c:v>0.44156666666666666</c:v>
                </c:pt>
                <c:pt idx="4">
                  <c:v>0.697633333333333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6B8-47E3-B999-F6860E8696E3}"/>
            </c:ext>
          </c:extLst>
        </c:ser>
        <c:ser>
          <c:idx val="3"/>
          <c:order val="1"/>
          <c:tx>
            <c:strRef>
              <c:f>Sheet4!$T$118</c:f>
              <c:strCache>
                <c:ptCount val="1"/>
                <c:pt idx="0">
                  <c:v>C71S</c:v>
                </c:pt>
              </c:strCache>
            </c:strRef>
          </c:tx>
          <c:spPr>
            <a:ln w="28575" cap="rnd" cmpd="sng" algn="ctr">
              <a:solidFill>
                <a:schemeClr val="accent4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T$126:$T$130</c:f>
                <c:numCache>
                  <c:formatCode>General</c:formatCode>
                  <c:ptCount val="5"/>
                  <c:pt idx="0">
                    <c:v>5.7671483421184845E-4</c:v>
                  </c:pt>
                  <c:pt idx="1">
                    <c:v>6.8047777333282516E-4</c:v>
                  </c:pt>
                  <c:pt idx="2">
                    <c:v>1.4901398144693125E-2</c:v>
                  </c:pt>
                  <c:pt idx="3">
                    <c:v>2.5002899831819518E-2</c:v>
                  </c:pt>
                  <c:pt idx="4">
                    <c:v>2.46809899237946E-2</c:v>
                  </c:pt>
                </c:numCache>
              </c:numRef>
            </c:plus>
            <c:minus>
              <c:numRef>
                <c:f>Sheet4!$T$126:$T$130</c:f>
                <c:numCache>
                  <c:formatCode>General</c:formatCode>
                  <c:ptCount val="5"/>
                  <c:pt idx="0">
                    <c:v>5.7671483421184845E-4</c:v>
                  </c:pt>
                  <c:pt idx="1">
                    <c:v>6.8047777333282516E-4</c:v>
                  </c:pt>
                  <c:pt idx="2">
                    <c:v>1.4901398144693125E-2</c:v>
                  </c:pt>
                  <c:pt idx="3">
                    <c:v>2.5002899831819518E-2</c:v>
                  </c:pt>
                  <c:pt idx="4">
                    <c:v>2.46809899237946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R$119:$R$123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T$119:$T$123</c:f>
              <c:numCache>
                <c:formatCode>General</c:formatCode>
                <c:ptCount val="5"/>
                <c:pt idx="0">
                  <c:v>1.5330000000000002E-2</c:v>
                </c:pt>
                <c:pt idx="1">
                  <c:v>2.2589999999999999E-2</c:v>
                </c:pt>
                <c:pt idx="2">
                  <c:v>0.16173333333333334</c:v>
                </c:pt>
                <c:pt idx="3">
                  <c:v>0.46560000000000001</c:v>
                </c:pt>
                <c:pt idx="4">
                  <c:v>0.6880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6B8-47E3-B999-F6860E8696E3}"/>
            </c:ext>
          </c:extLst>
        </c:ser>
        <c:ser>
          <c:idx val="0"/>
          <c:order val="2"/>
          <c:tx>
            <c:strRef>
              <c:f>Sheet4!$Q$77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 cmpd="sng" algn="ctr">
              <a:solidFill>
                <a:schemeClr val="accent1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Q$85:$Q$89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plus>
            <c:minus>
              <c:numRef>
                <c:f>Sheet4!$Q$85:$Q$89</c:f>
                <c:numCache>
                  <c:formatCode>General</c:formatCode>
                  <c:ptCount val="5"/>
                  <c:pt idx="0">
                    <c:v>1.7033486137605536E-3</c:v>
                  </c:pt>
                  <c:pt idx="1">
                    <c:v>1.5239149145102123E-3</c:v>
                  </c:pt>
                  <c:pt idx="2">
                    <c:v>1.2053491886862778E-3</c:v>
                  </c:pt>
                  <c:pt idx="3">
                    <c:v>1.6728767637416281E-3</c:v>
                  </c:pt>
                  <c:pt idx="4">
                    <c:v>6.7617798445872629E-3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P$78:$P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Q$78:$Q$82</c:f>
              <c:numCache>
                <c:formatCode>General</c:formatCode>
                <c:ptCount val="5"/>
                <c:pt idx="0">
                  <c:v>1.1679E-2</c:v>
                </c:pt>
                <c:pt idx="1">
                  <c:v>1.6923333333333335E-2</c:v>
                </c:pt>
                <c:pt idx="2">
                  <c:v>3.3476666666666662E-2</c:v>
                </c:pt>
                <c:pt idx="3">
                  <c:v>7.2386666666666669E-2</c:v>
                </c:pt>
                <c:pt idx="4">
                  <c:v>0.138033333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6B8-47E3-B999-F6860E8696E3}"/>
            </c:ext>
          </c:extLst>
        </c:ser>
        <c:ser>
          <c:idx val="1"/>
          <c:order val="3"/>
          <c:tx>
            <c:strRef>
              <c:f>Sheet4!$R$77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 cmpd="sng" algn="ctr">
              <a:solidFill>
                <a:schemeClr val="accent2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R$85:$R$89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plus>
            <c:minus>
              <c:numRef>
                <c:f>Sheet4!$R$85:$R$89</c:f>
                <c:numCache>
                  <c:formatCode>General</c:formatCode>
                  <c:ptCount val="5"/>
                  <c:pt idx="0">
                    <c:v>1.1742515346665147E-3</c:v>
                  </c:pt>
                  <c:pt idx="1">
                    <c:v>2.5483229779602111E-3</c:v>
                  </c:pt>
                  <c:pt idx="2">
                    <c:v>8.2563107176672305E-3</c:v>
                  </c:pt>
                  <c:pt idx="3">
                    <c:v>2.7907346702974109E-2</c:v>
                  </c:pt>
                  <c:pt idx="4">
                    <c:v>1.271278883644339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P$78:$P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R$78:$R$82</c:f>
              <c:numCache>
                <c:formatCode>General</c:formatCode>
                <c:ptCount val="5"/>
                <c:pt idx="0">
                  <c:v>1.4486666666666667E-2</c:v>
                </c:pt>
                <c:pt idx="1">
                  <c:v>2.3470000000000001E-2</c:v>
                </c:pt>
                <c:pt idx="2">
                  <c:v>0.16793333333333335</c:v>
                </c:pt>
                <c:pt idx="3">
                  <c:v>0.4995</c:v>
                </c:pt>
                <c:pt idx="4">
                  <c:v>0.6962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6B8-47E3-B999-F6860E8696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42011632"/>
        <c:axId val="1938910656"/>
      </c:lineChart>
      <c:catAx>
        <c:axId val="1942011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910656"/>
        <c:crosses val="autoZero"/>
        <c:auto val="1"/>
        <c:lblAlgn val="ctr"/>
        <c:lblOffset val="100"/>
        <c:noMultiLvlLbl val="0"/>
      </c:catAx>
      <c:valAx>
        <c:axId val="1938910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</a:t>
                </a:r>
                <a:r>
                  <a:rPr lang="en-US" baseline="0"/>
                  <a:t> </a:t>
                </a:r>
                <a:r>
                  <a:rPr lang="en-US"/>
                  <a:t>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2011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aseline="0"/>
              <a:t>SNP </a:t>
            </a:r>
            <a:r>
              <a:rPr lang="en-US" sz="1400" b="0" baseline="0"/>
              <a:t>(</a:t>
            </a:r>
            <a:r>
              <a:rPr lang="en-US" sz="1400" b="0" i="0" u="none" strike="noStrike" baseline="0">
                <a:effectLst/>
              </a:rPr>
              <a:t>5 mM</a:t>
            </a:r>
            <a:r>
              <a:rPr lang="en-US" sz="1400" b="0" baseline="0"/>
              <a:t>)</a:t>
            </a:r>
            <a:endParaRPr lang="en-US" sz="1400" b="0"/>
          </a:p>
        </c:rich>
      </c:tx>
      <c:layout>
        <c:manualLayout>
          <c:xMode val="edge"/>
          <c:yMode val="edge"/>
          <c:x val="0.40980714942118379"/>
          <c:y val="0.12024398358655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2"/>
          <c:order val="0"/>
          <c:tx>
            <c:strRef>
              <c:f>Sheet4!$AE$117</c:f>
              <c:strCache>
                <c:ptCount val="1"/>
                <c:pt idx="0">
                  <c:v>C83T</c:v>
                </c:pt>
              </c:strCache>
            </c:strRef>
          </c:tx>
          <c:spPr>
            <a:ln w="28575" cap="rnd" cmpd="sng" algn="ctr">
              <a:solidFill>
                <a:schemeClr val="accent3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E$125:$AE$129</c:f>
                <c:numCache>
                  <c:formatCode>General</c:formatCode>
                  <c:ptCount val="5"/>
                  <c:pt idx="0">
                    <c:v>3.0859790450789948E-3</c:v>
                  </c:pt>
                  <c:pt idx="1">
                    <c:v>4.175621710196779E-3</c:v>
                  </c:pt>
                  <c:pt idx="2">
                    <c:v>1.8118268865061755E-2</c:v>
                  </c:pt>
                  <c:pt idx="3">
                    <c:v>4.7362080472321605E-3</c:v>
                  </c:pt>
                  <c:pt idx="4">
                    <c:v>3.5749848484527433E-2</c:v>
                  </c:pt>
                </c:numCache>
              </c:numRef>
            </c:plus>
            <c:minus>
              <c:numRef>
                <c:f>Sheet4!$AE$125:$AE$129</c:f>
                <c:numCache>
                  <c:formatCode>General</c:formatCode>
                  <c:ptCount val="5"/>
                  <c:pt idx="0">
                    <c:v>3.0859790450789948E-3</c:v>
                  </c:pt>
                  <c:pt idx="1">
                    <c:v>4.175621710196779E-3</c:v>
                  </c:pt>
                  <c:pt idx="2">
                    <c:v>1.8118268865061755E-2</c:v>
                  </c:pt>
                  <c:pt idx="3">
                    <c:v>4.7362080472321605E-3</c:v>
                  </c:pt>
                  <c:pt idx="4">
                    <c:v>3.5749848484527433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AD$118:$AD$12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E$118:$AE$122</c:f>
              <c:numCache>
                <c:formatCode>General</c:formatCode>
                <c:ptCount val="5"/>
                <c:pt idx="0">
                  <c:v>2.6296666666666666E-2</c:v>
                </c:pt>
                <c:pt idx="1">
                  <c:v>6.9096666666666653E-2</c:v>
                </c:pt>
                <c:pt idx="2">
                  <c:v>0.36606666666666671</c:v>
                </c:pt>
                <c:pt idx="3">
                  <c:v>0.78496666666666659</c:v>
                </c:pt>
                <c:pt idx="4">
                  <c:v>0.8412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B3F-488A-B1F4-FB92BC3A8499}"/>
            </c:ext>
          </c:extLst>
        </c:ser>
        <c:ser>
          <c:idx val="3"/>
          <c:order val="1"/>
          <c:tx>
            <c:strRef>
              <c:f>Sheet4!$AF$117</c:f>
              <c:strCache>
                <c:ptCount val="1"/>
                <c:pt idx="0">
                  <c:v>C71S</c:v>
                </c:pt>
              </c:strCache>
            </c:strRef>
          </c:tx>
          <c:spPr>
            <a:ln w="28575" cap="rnd" cmpd="sng" algn="ctr">
              <a:solidFill>
                <a:schemeClr val="accent4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F$125:$AF$129</c:f>
                <c:numCache>
                  <c:formatCode>General</c:formatCode>
                  <c:ptCount val="5"/>
                  <c:pt idx="0">
                    <c:v>1.204512349459315E-3</c:v>
                  </c:pt>
                  <c:pt idx="1">
                    <c:v>2.3950191370147073E-3</c:v>
                  </c:pt>
                  <c:pt idx="2">
                    <c:v>6.718630812896316E-3</c:v>
                  </c:pt>
                  <c:pt idx="3">
                    <c:v>1.6592819732241609E-2</c:v>
                  </c:pt>
                  <c:pt idx="4">
                    <c:v>1.7239054498434637E-2</c:v>
                  </c:pt>
                </c:numCache>
              </c:numRef>
            </c:plus>
            <c:minus>
              <c:numRef>
                <c:f>Sheet4!$AF$125:$AF$129</c:f>
                <c:numCache>
                  <c:formatCode>General</c:formatCode>
                  <c:ptCount val="5"/>
                  <c:pt idx="0">
                    <c:v>1.204512349459315E-3</c:v>
                  </c:pt>
                  <c:pt idx="1">
                    <c:v>2.3950191370147073E-3</c:v>
                  </c:pt>
                  <c:pt idx="2">
                    <c:v>6.718630812896316E-3</c:v>
                  </c:pt>
                  <c:pt idx="3">
                    <c:v>1.6592819732241609E-2</c:v>
                  </c:pt>
                  <c:pt idx="4">
                    <c:v>1.723905449843463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AD$118:$AD$12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F$118:$AF$122</c:f>
              <c:numCache>
                <c:formatCode>General</c:formatCode>
                <c:ptCount val="5"/>
                <c:pt idx="0">
                  <c:v>1.7000000000000001E-2</c:v>
                </c:pt>
                <c:pt idx="1">
                  <c:v>6.1313333333333338E-2</c:v>
                </c:pt>
                <c:pt idx="2">
                  <c:v>0.43330000000000002</c:v>
                </c:pt>
                <c:pt idx="3">
                  <c:v>0.75826666666666664</c:v>
                </c:pt>
                <c:pt idx="4">
                  <c:v>0.80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B3F-488A-B1F4-FB92BC3A8499}"/>
            </c:ext>
          </c:extLst>
        </c:ser>
        <c:ser>
          <c:idx val="0"/>
          <c:order val="2"/>
          <c:tx>
            <c:strRef>
              <c:f>Sheet4!$Z$77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 cmpd="sng" algn="ctr">
              <a:solidFill>
                <a:schemeClr val="accent1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Z$85:$Z$89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plus>
            <c:minus>
              <c:numRef>
                <c:f>Sheet4!$Z$85:$Z$89</c:f>
                <c:numCache>
                  <c:formatCode>General</c:formatCode>
                  <c:ptCount val="5"/>
                  <c:pt idx="0">
                    <c:v>1.0011576632412435E-3</c:v>
                  </c:pt>
                  <c:pt idx="1">
                    <c:v>5.1160091868564855E-3</c:v>
                  </c:pt>
                  <c:pt idx="2">
                    <c:v>1.4012553895227903E-2</c:v>
                  </c:pt>
                  <c:pt idx="3">
                    <c:v>1.8121839494561986E-2</c:v>
                  </c:pt>
                  <c:pt idx="4">
                    <c:v>5.4052489921063582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Y$78:$Y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Z$78:$Z$82</c:f>
              <c:numCache>
                <c:formatCode>General</c:formatCode>
                <c:ptCount val="5"/>
                <c:pt idx="0">
                  <c:v>1.6086666666666666E-2</c:v>
                </c:pt>
                <c:pt idx="1">
                  <c:v>3.9949999999999999E-2</c:v>
                </c:pt>
                <c:pt idx="2">
                  <c:v>0.18233333333333332</c:v>
                </c:pt>
                <c:pt idx="3">
                  <c:v>0.36370666666666668</c:v>
                </c:pt>
                <c:pt idx="4">
                  <c:v>0.3819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B3F-488A-B1F4-FB92BC3A8499}"/>
            </c:ext>
          </c:extLst>
        </c:ser>
        <c:ser>
          <c:idx val="1"/>
          <c:order val="3"/>
          <c:tx>
            <c:strRef>
              <c:f>Sheet4!$AA$77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 cmpd="sng" algn="ctr">
              <a:solidFill>
                <a:schemeClr val="accent2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AA$85:$AA$89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plus>
            <c:minus>
              <c:numRef>
                <c:f>Sheet4!$AA$85:$AA$89</c:f>
                <c:numCache>
                  <c:formatCode>General</c:formatCode>
                  <c:ptCount val="5"/>
                  <c:pt idx="0">
                    <c:v>1.4605021967346249E-3</c:v>
                  </c:pt>
                  <c:pt idx="1">
                    <c:v>6.7194233383527369E-3</c:v>
                  </c:pt>
                  <c:pt idx="2">
                    <c:v>1.1165220553128364E-2</c:v>
                  </c:pt>
                  <c:pt idx="3">
                    <c:v>1.9529976958511785E-2</c:v>
                  </c:pt>
                  <c:pt idx="4">
                    <c:v>1.697061185304365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Y$78:$Y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AA$78:$AA$82</c:f>
              <c:numCache>
                <c:formatCode>General</c:formatCode>
                <c:ptCount val="5"/>
                <c:pt idx="0">
                  <c:v>1.7393333333333334E-2</c:v>
                </c:pt>
                <c:pt idx="1">
                  <c:v>6.9830000000000003E-2</c:v>
                </c:pt>
                <c:pt idx="2">
                  <c:v>0.41741</c:v>
                </c:pt>
                <c:pt idx="3">
                  <c:v>0.7954</c:v>
                </c:pt>
                <c:pt idx="4">
                  <c:v>0.8158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B3F-488A-B1F4-FB92BC3A84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42011632"/>
        <c:axId val="1938910656"/>
      </c:lineChart>
      <c:catAx>
        <c:axId val="1942011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910656"/>
        <c:crosses val="autoZero"/>
        <c:auto val="1"/>
        <c:lblAlgn val="ctr"/>
        <c:lblOffset val="100"/>
        <c:noMultiLvlLbl val="0"/>
      </c:catAx>
      <c:valAx>
        <c:axId val="1938910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</a:t>
                </a:r>
                <a:r>
                  <a:rPr lang="en-US" baseline="0"/>
                  <a:t> </a:t>
                </a:r>
                <a:r>
                  <a:rPr lang="en-US"/>
                  <a:t>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2011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Unexposed</a:t>
            </a:r>
            <a:endParaRPr lang="en-US" sz="1400">
              <a:effectLst/>
            </a:endParaRPr>
          </a:p>
        </c:rich>
      </c:tx>
      <c:layout>
        <c:manualLayout>
          <c:xMode val="edge"/>
          <c:yMode val="edge"/>
          <c:x val="0.39301451498945705"/>
          <c:y val="0.134328410831045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2"/>
          <c:order val="0"/>
          <c:tx>
            <c:strRef>
              <c:f>Sheet4!$G$119</c:f>
              <c:strCache>
                <c:ptCount val="1"/>
                <c:pt idx="0">
                  <c:v>C83T</c:v>
                </c:pt>
              </c:strCache>
            </c:strRef>
          </c:tx>
          <c:spPr>
            <a:ln w="28575" cap="rnd" cmpd="sng" algn="ctr">
              <a:solidFill>
                <a:schemeClr val="accent3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G$127:$G$131</c:f>
                <c:numCache>
                  <c:formatCode>General</c:formatCode>
                  <c:ptCount val="5"/>
                  <c:pt idx="0">
                    <c:v>4.108730541988202E-4</c:v>
                  </c:pt>
                  <c:pt idx="1">
                    <c:v>4.2764724559696023E-3</c:v>
                  </c:pt>
                  <c:pt idx="2">
                    <c:v>9.228578799938056E-4</c:v>
                  </c:pt>
                  <c:pt idx="3">
                    <c:v>2.4536741158244047E-2</c:v>
                  </c:pt>
                  <c:pt idx="4">
                    <c:v>2.0257714579882888E-2</c:v>
                  </c:pt>
                </c:numCache>
              </c:numRef>
            </c:plus>
            <c:minus>
              <c:numRef>
                <c:f>Sheet4!$G$127:$G$131</c:f>
                <c:numCache>
                  <c:formatCode>General</c:formatCode>
                  <c:ptCount val="5"/>
                  <c:pt idx="0">
                    <c:v>4.108730541988202E-4</c:v>
                  </c:pt>
                  <c:pt idx="1">
                    <c:v>4.2764724559696023E-3</c:v>
                  </c:pt>
                  <c:pt idx="2">
                    <c:v>9.228578799938056E-4</c:v>
                  </c:pt>
                  <c:pt idx="3">
                    <c:v>2.4536741158244047E-2</c:v>
                  </c:pt>
                  <c:pt idx="4">
                    <c:v>2.025771457988288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F$120:$F$124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G$120:$G$124</c:f>
              <c:numCache>
                <c:formatCode>General</c:formatCode>
                <c:ptCount val="5"/>
                <c:pt idx="0">
                  <c:v>1.4356666666666665E-2</c:v>
                </c:pt>
                <c:pt idx="1">
                  <c:v>6.6676666666666662E-2</c:v>
                </c:pt>
                <c:pt idx="2">
                  <c:v>0.36513333333333337</c:v>
                </c:pt>
                <c:pt idx="3">
                  <c:v>0.67026666666666657</c:v>
                </c:pt>
                <c:pt idx="4">
                  <c:v>0.8624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C2-4CED-9418-FA1826C1D58E}"/>
            </c:ext>
          </c:extLst>
        </c:ser>
        <c:ser>
          <c:idx val="3"/>
          <c:order val="1"/>
          <c:tx>
            <c:strRef>
              <c:f>Sheet4!$H$119</c:f>
              <c:strCache>
                <c:ptCount val="1"/>
                <c:pt idx="0">
                  <c:v>C71S</c:v>
                </c:pt>
              </c:strCache>
            </c:strRef>
          </c:tx>
          <c:spPr>
            <a:ln w="28575" cap="rnd" cmpd="sng" algn="ctr">
              <a:solidFill>
                <a:schemeClr val="accent4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H$127:$H$130</c:f>
                <c:numCache>
                  <c:formatCode>General</c:formatCode>
                  <c:ptCount val="4"/>
                  <c:pt idx="0">
                    <c:v>1.1849120923792893E-3</c:v>
                  </c:pt>
                  <c:pt idx="1">
                    <c:v>2.6291855519659829E-3</c:v>
                  </c:pt>
                  <c:pt idx="2">
                    <c:v>1.1186897097348611E-2</c:v>
                  </c:pt>
                  <c:pt idx="3">
                    <c:v>9.9549820023276045E-3</c:v>
                  </c:pt>
                </c:numCache>
              </c:numRef>
            </c:plus>
            <c:minus>
              <c:numRef>
                <c:f>Sheet4!$H$127:$H$131</c:f>
                <c:numCache>
                  <c:formatCode>General</c:formatCode>
                  <c:ptCount val="5"/>
                  <c:pt idx="0">
                    <c:v>1.1849120923792893E-3</c:v>
                  </c:pt>
                  <c:pt idx="1">
                    <c:v>2.6291855519659829E-3</c:v>
                  </c:pt>
                  <c:pt idx="2">
                    <c:v>1.1186897097348611E-2</c:v>
                  </c:pt>
                  <c:pt idx="3">
                    <c:v>9.9549820023276045E-3</c:v>
                  </c:pt>
                  <c:pt idx="4">
                    <c:v>1.2464416017875323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F$120:$F$124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H$120:$H$124</c:f>
              <c:numCache>
                <c:formatCode>General</c:formatCode>
                <c:ptCount val="5"/>
                <c:pt idx="0">
                  <c:v>1.6583333333333335E-2</c:v>
                </c:pt>
                <c:pt idx="1">
                  <c:v>7.1173333333333338E-2</c:v>
                </c:pt>
                <c:pt idx="2">
                  <c:v>0.34186666666666671</c:v>
                </c:pt>
                <c:pt idx="3">
                  <c:v>0.65016666666666667</c:v>
                </c:pt>
                <c:pt idx="4">
                  <c:v>0.857266666666666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9C2-4CED-9418-FA1826C1D58E}"/>
            </c:ext>
          </c:extLst>
        </c:ser>
        <c:ser>
          <c:idx val="0"/>
          <c:order val="2"/>
          <c:tx>
            <c:strRef>
              <c:f>Sheet4!$G$77</c:f>
              <c:strCache>
                <c:ptCount val="1"/>
                <c:pt idx="0">
                  <c:v>tsa1tsa2Δ</c:v>
                </c:pt>
              </c:strCache>
            </c:strRef>
          </c:tx>
          <c:spPr>
            <a:ln w="28575" cap="rnd" cmpd="sng" algn="ctr">
              <a:solidFill>
                <a:schemeClr val="accent1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G$85:$G$89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plus>
            <c:minus>
              <c:numRef>
                <c:f>Sheet4!$G$85:$G$89</c:f>
                <c:numCache>
                  <c:formatCode>General</c:formatCode>
                  <c:ptCount val="5"/>
                  <c:pt idx="0">
                    <c:v>1.0933434958877288E-3</c:v>
                  </c:pt>
                  <c:pt idx="1">
                    <c:v>1.9406055755871664E-3</c:v>
                  </c:pt>
                  <c:pt idx="2">
                    <c:v>4.347932458843711E-3</c:v>
                  </c:pt>
                  <c:pt idx="3">
                    <c:v>7.5147632475458951E-3</c:v>
                  </c:pt>
                  <c:pt idx="4">
                    <c:v>1.23953620358584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F$78:$F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G$78:$G$82</c:f>
              <c:numCache>
                <c:formatCode>General</c:formatCode>
                <c:ptCount val="5"/>
                <c:pt idx="0">
                  <c:v>1.24E-2</c:v>
                </c:pt>
                <c:pt idx="1">
                  <c:v>2.8539999999999999E-2</c:v>
                </c:pt>
                <c:pt idx="2">
                  <c:v>0.12238666666666669</c:v>
                </c:pt>
                <c:pt idx="3">
                  <c:v>0.38646666666666668</c:v>
                </c:pt>
                <c:pt idx="4">
                  <c:v>0.5266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9C2-4CED-9418-FA1826C1D58E}"/>
            </c:ext>
          </c:extLst>
        </c:ser>
        <c:ser>
          <c:idx val="1"/>
          <c:order val="3"/>
          <c:tx>
            <c:strRef>
              <c:f>Sheet4!$H$77</c:f>
              <c:strCache>
                <c:ptCount val="1"/>
                <c:pt idx="0">
                  <c:v>hPrxI</c:v>
                </c:pt>
              </c:strCache>
            </c:strRef>
          </c:tx>
          <c:spPr>
            <a:ln w="28575" cap="rnd" cmpd="sng" algn="ctr">
              <a:solidFill>
                <a:schemeClr val="accent2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H$85:$H$89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plus>
            <c:minus>
              <c:numRef>
                <c:f>Sheet4!$H$85:$H$89</c:f>
                <c:numCache>
                  <c:formatCode>General</c:formatCode>
                  <c:ptCount val="5"/>
                  <c:pt idx="0">
                    <c:v>2.0963301266737544E-3</c:v>
                  </c:pt>
                  <c:pt idx="1">
                    <c:v>3.3186367683131594E-3</c:v>
                  </c:pt>
                  <c:pt idx="2">
                    <c:v>8.9110418395755859E-3</c:v>
                  </c:pt>
                  <c:pt idx="3">
                    <c:v>1.4746355481948756E-2</c:v>
                  </c:pt>
                  <c:pt idx="4">
                    <c:v>2.004461689997259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4!$F$78:$F$82</c:f>
              <c:numCache>
                <c:formatCode>General</c:formatCode>
                <c:ptCount val="5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24</c:v>
                </c:pt>
                <c:pt idx="4">
                  <c:v>32</c:v>
                </c:pt>
              </c:numCache>
            </c:numRef>
          </c:cat>
          <c:val>
            <c:numRef>
              <c:f>Sheet4!$H$78:$H$82</c:f>
              <c:numCache>
                <c:formatCode>General</c:formatCode>
                <c:ptCount val="5"/>
                <c:pt idx="0">
                  <c:v>1.6390000000000002E-2</c:v>
                </c:pt>
                <c:pt idx="1">
                  <c:v>7.0330000000000004E-2</c:v>
                </c:pt>
                <c:pt idx="2">
                  <c:v>0.39206666666666662</c:v>
                </c:pt>
                <c:pt idx="3">
                  <c:v>0.66570000000000007</c:v>
                </c:pt>
                <c:pt idx="4">
                  <c:v>0.8513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9C2-4CED-9418-FA1826C1D5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42011632"/>
        <c:axId val="1938910656"/>
      </c:lineChart>
      <c:catAx>
        <c:axId val="1942011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8910656"/>
        <c:crosses val="autoZero"/>
        <c:auto val="1"/>
        <c:lblAlgn val="ctr"/>
        <c:lblOffset val="100"/>
        <c:noMultiLvlLbl val="0"/>
      </c:catAx>
      <c:valAx>
        <c:axId val="1938910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.D.</a:t>
                </a:r>
                <a:r>
                  <a:rPr lang="en-US" baseline="0"/>
                  <a:t> </a:t>
                </a:r>
                <a:r>
                  <a:rPr lang="en-US"/>
                  <a:t>600 n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2011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106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 mods="ignoreCSTransforms">
      <cs:styleClr val="0">
        <a:shade val="25000"/>
      </cs:styl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 mods="ignoreCSTransforms">
      <cs:styleClr val="0">
        <a:tint val="25000"/>
      </cs:styl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06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 mods="ignoreCSTransforms">
      <cs:styleClr val="0">
        <a:shade val="25000"/>
      </cs:styl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 mods="ignoreCSTransforms">
      <cs:styleClr val="0">
        <a:tint val="25000"/>
      </cs:styl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1E7FB7BB-178B-FC44-A927-9ABC7567782A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0DF1E705-7518-A048-B710-11DBB57259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134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D2CA4-99A5-034E-9085-37589FFDB966}" type="datetimeFigureOut">
              <a:rPr lang="en-US" smtClean="0"/>
              <a:pPr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0FFB2-1641-6F43-9508-42B1EC343AC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1372FAD-5DCC-4B49-828A-97557F5F4B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1775783"/>
              </p:ext>
            </p:extLst>
          </p:nvPr>
        </p:nvGraphicFramePr>
        <p:xfrm>
          <a:off x="142547" y="386859"/>
          <a:ext cx="2863872" cy="2578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63ECC82-761A-4510-971D-9C561AAC30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0062097"/>
              </p:ext>
            </p:extLst>
          </p:nvPr>
        </p:nvGraphicFramePr>
        <p:xfrm>
          <a:off x="142547" y="2965684"/>
          <a:ext cx="2807677" cy="2578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62BB1678-6B8A-4908-BF7F-01C34EBCDB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7807135"/>
              </p:ext>
            </p:extLst>
          </p:nvPr>
        </p:nvGraphicFramePr>
        <p:xfrm>
          <a:off x="82963" y="5661991"/>
          <a:ext cx="2983040" cy="2578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C652984-8567-45CC-9203-27AB0CEEDB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9134934"/>
              </p:ext>
            </p:extLst>
          </p:nvPr>
        </p:nvGraphicFramePr>
        <p:xfrm>
          <a:off x="3439638" y="166498"/>
          <a:ext cx="2863873" cy="3019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B8649A94-38AD-4542-B389-102E31295F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0409422"/>
              </p:ext>
            </p:extLst>
          </p:nvPr>
        </p:nvGraphicFramePr>
        <p:xfrm>
          <a:off x="3388158" y="2757047"/>
          <a:ext cx="2874511" cy="3019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3BBA3033-D78A-46F8-9DCE-73E6EDF4A2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2006602"/>
              </p:ext>
            </p:extLst>
          </p:nvPr>
        </p:nvGraphicFramePr>
        <p:xfrm>
          <a:off x="3429000" y="5661991"/>
          <a:ext cx="2874511" cy="2799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4EC1509-5A3A-4A44-89B3-28F77C879CC7}"/>
              </a:ext>
            </a:extLst>
          </p:cNvPr>
          <p:cNvSpPr txBox="1"/>
          <p:nvPr/>
        </p:nvSpPr>
        <p:spPr>
          <a:xfrm>
            <a:off x="-17023" y="166498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66CF5F4-3095-4C9C-9D00-AEB8EBE66552}"/>
              </a:ext>
            </a:extLst>
          </p:cNvPr>
          <p:cNvSpPr txBox="1"/>
          <p:nvPr/>
        </p:nvSpPr>
        <p:spPr>
          <a:xfrm>
            <a:off x="38921" y="5436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1FEFAE-BBEC-4BA4-9BDD-B32A9D3ACA70}"/>
              </a:ext>
            </a:extLst>
          </p:cNvPr>
          <p:cNvSpPr txBox="1"/>
          <p:nvPr/>
        </p:nvSpPr>
        <p:spPr>
          <a:xfrm>
            <a:off x="50710" y="338380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5C2106-52BE-4D6C-A544-EB9E8145D3A8}"/>
              </a:ext>
            </a:extLst>
          </p:cNvPr>
          <p:cNvSpPr txBox="1"/>
          <p:nvPr/>
        </p:nvSpPr>
        <p:spPr>
          <a:xfrm>
            <a:off x="50710" y="593908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D2971A5-66D8-4C45-9C19-C8D8B8F15DE6}"/>
              </a:ext>
            </a:extLst>
          </p:cNvPr>
          <p:cNvSpPr txBox="1"/>
          <p:nvPr/>
        </p:nvSpPr>
        <p:spPr>
          <a:xfrm>
            <a:off x="3262767" y="5553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EEA85F-36DF-46A7-9D73-5D8C62C7678D}"/>
              </a:ext>
            </a:extLst>
          </p:cNvPr>
          <p:cNvSpPr txBox="1"/>
          <p:nvPr/>
        </p:nvSpPr>
        <p:spPr>
          <a:xfrm>
            <a:off x="3274556" y="339553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E08937D-C230-4173-818E-9CD849A86A35}"/>
              </a:ext>
            </a:extLst>
          </p:cNvPr>
          <p:cNvSpPr txBox="1"/>
          <p:nvPr/>
        </p:nvSpPr>
        <p:spPr>
          <a:xfrm>
            <a:off x="3274556" y="595081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15" name="Rectangle 1"/>
          <p:cNvSpPr>
            <a:spLocks noChangeArrowheads="1"/>
          </p:cNvSpPr>
          <p:nvPr/>
        </p:nvSpPr>
        <p:spPr bwMode="auto">
          <a:xfrm>
            <a:off x="337968" y="8509068"/>
            <a:ext cx="6252726" cy="46166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S1 (A-F) </a:t>
            </a:r>
            <a:r>
              <a:rPr lang="en-US" sz="12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ctor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sa1tsa2∆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1" u="none" strike="noStrike" cap="none" normalizeH="0" baseline="0" dirty="0" err="1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I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sa1</a:t>
            </a:r>
            <a:r>
              <a:rPr lang="en-US" sz="1200" i="1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48S,C170S</a:t>
            </a:r>
            <a:r>
              <a:rPr lang="en-US" sz="12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</a:t>
            </a:r>
            <a:r>
              <a:rPr kumimoji="0" lang="en-US" sz="1200" b="0" i="1" u="none" strike="noStrike" cap="none" normalizeH="0" baseline="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52S,C173S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grown in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sence of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mM </a:t>
            </a:r>
            <a:r>
              <a:rPr kumimoji="0" lang="en-US" sz="1200" b="0" i="0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kumimoji="0" lang="en-US" sz="1200" b="0" i="0" strike="noStrike" cap="none" normalizeH="0" baseline="-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sz="1200" b="0" i="0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kumimoji="0" lang="en-US" sz="1200" b="0" i="0" strike="noStrike" cap="none" normalizeH="0" baseline="-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5mM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P and </a:t>
            </a:r>
            <a:r>
              <a:rPr lang="en-IN" sz="1200" dirty="0"/>
              <a:t>recorded their absorbance (OD</a:t>
            </a:r>
            <a:r>
              <a:rPr lang="en-IN" sz="1200" baseline="-25000" dirty="0"/>
              <a:t>600</a:t>
            </a:r>
            <a:r>
              <a:rPr lang="en-IN" sz="1200" dirty="0"/>
              <a:t>) at every eight hours.</a:t>
            </a:r>
            <a:endParaRPr kumimoji="0" lang="en-US" sz="1800" b="0" i="0" u="none" strike="noStrike" cap="none" normalizeH="0" baseline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910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8689DEE-BB0F-4C2B-9861-7431E76A4A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2232854"/>
              </p:ext>
            </p:extLst>
          </p:nvPr>
        </p:nvGraphicFramePr>
        <p:xfrm>
          <a:off x="1696406" y="2648749"/>
          <a:ext cx="2863872" cy="24094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4B28F3E-E3E1-4C12-91C1-FEF9410A82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8581231"/>
              </p:ext>
            </p:extLst>
          </p:nvPr>
        </p:nvGraphicFramePr>
        <p:xfrm>
          <a:off x="1757536" y="5093871"/>
          <a:ext cx="2837911" cy="2543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17FBB4B7-5529-423C-BAD4-1AF572D048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4224055"/>
              </p:ext>
            </p:extLst>
          </p:nvPr>
        </p:nvGraphicFramePr>
        <p:xfrm>
          <a:off x="1658518" y="457201"/>
          <a:ext cx="2814134" cy="2423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Rectangle 1">
            <a:extLst>
              <a:ext uri="{FF2B5EF4-FFF2-40B4-BE49-F238E27FC236}">
                <a16:creationId xmlns:a16="http://schemas.microsoft.com/office/drawing/2014/main" id="{A6608020-090A-48DF-BF99-DBAD9FEBAF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766" y="8047403"/>
            <a:ext cx="6252726" cy="46166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S2 (A-C)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ctor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tsa1tsa2∆)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1" u="none" strike="noStrike" cap="none" normalizeH="0" baseline="0" dirty="0" err="1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</a:t>
            </a:r>
            <a:r>
              <a:rPr lang="en-US" sz="1200" i="1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71S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kumimoji="0" lang="en-US" sz="1200" b="0" i="1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xI</a:t>
            </a:r>
            <a:r>
              <a:rPr kumimoji="0" lang="en-US" sz="1200" b="0" i="1" u="none" strike="noStrike" cap="none" normalizeH="0" baseline="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83T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grown in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esence of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mM </a:t>
            </a:r>
            <a:r>
              <a:rPr kumimoji="0" lang="en-US" sz="1200" b="0" i="0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kumimoji="0" lang="en-US" sz="1200" b="0" i="0" strike="noStrike" cap="none" normalizeH="0" baseline="-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sz="1200" b="0" i="0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kumimoji="0" lang="en-US" sz="1200" b="0" i="0" strike="noStrike" cap="none" normalizeH="0" baseline="-3000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sz="1200" b="0" i="0" strike="noStrike" cap="none" normalizeH="0" baseline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strike="noStrike" cap="none" normalizeH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cap="none" normalizeH="0" dirty="0">
                <a:ln>
                  <a:noFill/>
                </a:ln>
                <a:solidFill>
                  <a:schemeClr val="tx1">
                    <a:lumMod val="85000"/>
                    <a:lumOff val="15000"/>
                  </a:schemeClr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mM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P and </a:t>
            </a:r>
            <a:r>
              <a:rPr lang="en-IN" sz="1200" dirty="0"/>
              <a:t>recorded their absorbance (OD</a:t>
            </a:r>
            <a:r>
              <a:rPr lang="en-IN" sz="1200" baseline="-25000" dirty="0"/>
              <a:t>600</a:t>
            </a:r>
            <a:r>
              <a:rPr lang="en-IN" sz="1200" dirty="0"/>
              <a:t>) at every eight hours.</a:t>
            </a:r>
            <a:endParaRPr kumimoji="0" lang="en-US" sz="1800" b="0" i="0" u="none" strike="noStrike" cap="none" normalizeH="0" baseline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8F35F9E-7745-48F3-9EEC-D2E519360776}"/>
              </a:ext>
            </a:extLst>
          </p:cNvPr>
          <p:cNvSpPr txBox="1"/>
          <p:nvPr/>
        </p:nvSpPr>
        <p:spPr>
          <a:xfrm>
            <a:off x="746013" y="7249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AB63BB-D0DB-4748-83D9-80EFAD20D7B8}"/>
              </a:ext>
            </a:extLst>
          </p:cNvPr>
          <p:cNvSpPr txBox="1"/>
          <p:nvPr/>
        </p:nvSpPr>
        <p:spPr>
          <a:xfrm>
            <a:off x="754029" y="312270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2B4D5B-52A8-4102-89CA-528FDFA1C0BE}"/>
              </a:ext>
            </a:extLst>
          </p:cNvPr>
          <p:cNvSpPr txBox="1"/>
          <p:nvPr/>
        </p:nvSpPr>
        <p:spPr>
          <a:xfrm>
            <a:off x="754029" y="537260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0CEE9F1-C0E8-4A38-AFF6-7ACB90C4FA2F}"/>
              </a:ext>
            </a:extLst>
          </p:cNvPr>
          <p:cNvSpPr txBox="1"/>
          <p:nvPr/>
        </p:nvSpPr>
        <p:spPr>
          <a:xfrm>
            <a:off x="-17023" y="131328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921990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A1414D4-3687-40F2-9FAF-AB3BAF24698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2315" r="2026" b="18178"/>
          <a:stretch/>
        </p:blipFill>
        <p:spPr>
          <a:xfrm>
            <a:off x="1481069" y="1097587"/>
            <a:ext cx="4410513" cy="150611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678B53C-2DC9-4B66-8373-D9787AC628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t="21962" r="2026" b="17826"/>
          <a:stretch/>
        </p:blipFill>
        <p:spPr>
          <a:xfrm>
            <a:off x="1482826" y="2674036"/>
            <a:ext cx="4410969" cy="152409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1E0B13D-A9C0-49A5-B267-39D251306F5A}"/>
              </a:ext>
            </a:extLst>
          </p:cNvPr>
          <p:cNvSpPr txBox="1"/>
          <p:nvPr/>
        </p:nvSpPr>
        <p:spPr>
          <a:xfrm>
            <a:off x="904803" y="1747312"/>
            <a:ext cx="578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vector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72F0E60-4B41-492A-8323-FB97AD35F4A9}"/>
              </a:ext>
            </a:extLst>
          </p:cNvPr>
          <p:cNvSpPr/>
          <p:nvPr/>
        </p:nvSpPr>
        <p:spPr>
          <a:xfrm rot="16200000">
            <a:off x="326572" y="1689175"/>
            <a:ext cx="85763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/>
              <a:t>tsa1tsa2∆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49C409-7080-47A9-AB10-DB9AA25BEEFC}"/>
              </a:ext>
            </a:extLst>
          </p:cNvPr>
          <p:cNvSpPr txBox="1"/>
          <p:nvPr/>
        </p:nvSpPr>
        <p:spPr>
          <a:xfrm>
            <a:off x="219797" y="3184867"/>
            <a:ext cx="148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WT (empty vector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1BADDBF-3DB4-4065-9068-B2AC05BAD4E8}"/>
              </a:ext>
            </a:extLst>
          </p:cNvPr>
          <p:cNvCxnSpPr>
            <a:cxnSpLocks/>
          </p:cNvCxnSpPr>
          <p:nvPr/>
        </p:nvCxnSpPr>
        <p:spPr>
          <a:xfrm>
            <a:off x="926634" y="1329356"/>
            <a:ext cx="1" cy="118324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424B5D8-0328-487E-A3FD-909BBBC82C3A}"/>
              </a:ext>
            </a:extLst>
          </p:cNvPr>
          <p:cNvSpPr txBox="1"/>
          <p:nvPr/>
        </p:nvSpPr>
        <p:spPr>
          <a:xfrm>
            <a:off x="1845811" y="834565"/>
            <a:ext cx="753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erg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760C86-B111-4AB5-A5F0-3B1ECFDB98D1}"/>
              </a:ext>
            </a:extLst>
          </p:cNvPr>
          <p:cNvSpPr txBox="1"/>
          <p:nvPr/>
        </p:nvSpPr>
        <p:spPr>
          <a:xfrm>
            <a:off x="3458173" y="844859"/>
            <a:ext cx="45500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F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7AED9AD-0B65-4DE7-97A4-DA0BCAC98701}"/>
              </a:ext>
            </a:extLst>
          </p:cNvPr>
          <p:cNvSpPr txBox="1"/>
          <p:nvPr/>
        </p:nvSpPr>
        <p:spPr>
          <a:xfrm>
            <a:off x="4921930" y="834565"/>
            <a:ext cx="45500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ACD2A6-F959-4492-8165-83EB46A0CADC}"/>
              </a:ext>
            </a:extLst>
          </p:cNvPr>
          <p:cNvSpPr txBox="1"/>
          <p:nvPr/>
        </p:nvSpPr>
        <p:spPr>
          <a:xfrm>
            <a:off x="95281" y="269827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792AAF5-8561-405E-9E05-52EDDE1AAA5C}"/>
              </a:ext>
            </a:extLst>
          </p:cNvPr>
          <p:cNvSpPr/>
          <p:nvPr/>
        </p:nvSpPr>
        <p:spPr>
          <a:xfrm>
            <a:off x="616887" y="4572000"/>
            <a:ext cx="593860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Fig S3: </a:t>
            </a:r>
            <a:r>
              <a:rPr lang="en-US" sz="12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ctor 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sa1tsa2∆</a:t>
            </a:r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WT(empty vector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train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were grown to OD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0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1 and treated with 1 mM  H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or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15 minutes and then incubated with DCFDA for 10 minutes in the dark. The cells were then washed with the same media and were mounted onto 1% Agarose blocks and analysed by confocal microscop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41683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791</TotalTime>
  <Words>308</Words>
  <Application>Microsoft Office PowerPoint</Application>
  <PresentationFormat>On-screen Show (4:3)</PresentationFormat>
  <Paragraphs>4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IH</dc:creator>
  <cp:lastModifiedBy>Adesh Saini</cp:lastModifiedBy>
  <cp:revision>1513</cp:revision>
  <cp:lastPrinted>2020-07-11T13:28:10Z</cp:lastPrinted>
  <dcterms:created xsi:type="dcterms:W3CDTF">2016-09-05T15:57:58Z</dcterms:created>
  <dcterms:modified xsi:type="dcterms:W3CDTF">2020-09-07T08:09:57Z</dcterms:modified>
</cp:coreProperties>
</file>